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8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AURKA</a:t>
            </a:r>
            <a:r>
              <a:rPr lang="en-GB" sz="1600" dirty="0" smtClean="0"/>
              <a:t> gene. A) Wild (Template</a:t>
            </a:r>
            <a:r>
              <a:rPr lang="en-US" sz="1600" dirty="0" smtClean="0"/>
              <a:t> 5l8l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5l8l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071538" y="428605"/>
            <a:ext cx="2641639" cy="23574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86380" y="114300"/>
            <a:ext cx="3143272" cy="2957510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071538" y="3052772"/>
            <a:ext cx="2643206" cy="24479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40713" y="3143248"/>
            <a:ext cx="3188939" cy="2734410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52</cp:revision>
  <dcterms:created xsi:type="dcterms:W3CDTF">2018-05-10T07:33:24Z</dcterms:created>
  <dcterms:modified xsi:type="dcterms:W3CDTF">2018-05-29T06:51:09Z</dcterms:modified>
</cp:coreProperties>
</file>